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9364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4477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3073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8152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7313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8316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9688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7122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1335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4387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6662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1452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1420;p8"/>
          <p:cNvSpPr txBox="1">
            <a:spLocks/>
          </p:cNvSpPr>
          <p:nvPr/>
        </p:nvSpPr>
        <p:spPr>
          <a:xfrm>
            <a:off x="1424354" y="5551735"/>
            <a:ext cx="9249506" cy="1049822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t" anchorCtr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ts val="0"/>
              </a:spcBef>
            </a:pPr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: </a:t>
            </a:r>
            <a:b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rst plane of a multivariate analysis based on SNPs obtained from targeted capture sequences of 272 accessions (Yang et al. 2019). With </a:t>
            </a:r>
            <a:r>
              <a:rPr lang="en-US" sz="1200" i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officinarum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green, </a:t>
            </a:r>
            <a:r>
              <a:rPr lang="en-US" sz="1200" i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robustum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blue, </a:t>
            </a:r>
            <a:r>
              <a:rPr lang="en-US" sz="1200" i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spontaneum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red and with interspecific hybrids (modern cultivars, </a:t>
            </a:r>
            <a:r>
              <a:rPr lang="en-US" sz="1200" i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barberi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sinense)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orange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oupe 7"/>
          <p:cNvGrpSpPr/>
          <p:nvPr/>
        </p:nvGrpSpPr>
        <p:grpSpPr>
          <a:xfrm>
            <a:off x="1385521" y="148004"/>
            <a:ext cx="9315450" cy="5067300"/>
            <a:chOff x="1385521" y="148004"/>
            <a:chExt cx="9315450" cy="5067300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85521" y="148004"/>
              <a:ext cx="9315450" cy="5067300"/>
            </a:xfrm>
            <a:prstGeom prst="rect">
              <a:avLst/>
            </a:prstGeom>
          </p:spPr>
        </p:pic>
        <p:sp>
          <p:nvSpPr>
            <p:cNvPr id="6" name="ZoneTexte 5"/>
            <p:cNvSpPr txBox="1"/>
            <p:nvPr/>
          </p:nvSpPr>
          <p:spPr>
            <a:xfrm>
              <a:off x="6151091" y="308183"/>
              <a:ext cx="4379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2</a:t>
              </a: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6.94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1527065" y="2681654"/>
              <a:ext cx="4892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</a:t>
              </a:r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1</a:t>
              </a:r>
              <a:endParaRPr lang="fr-FR" sz="800" dirty="0" smtClean="0">
                <a:solidFill>
                  <a:schemeClr val="bg1">
                    <a:lumMod val="65000"/>
                  </a:schemeClr>
                </a:solidFill>
              </a:endParaRP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20.67</a:t>
              </a:r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2014907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4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ompidor</dc:creator>
  <cp:lastModifiedBy>pompidor</cp:lastModifiedBy>
  <cp:revision>9</cp:revision>
  <dcterms:created xsi:type="dcterms:W3CDTF">2020-09-15T06:59:05Z</dcterms:created>
  <dcterms:modified xsi:type="dcterms:W3CDTF">2020-12-09T13:58:46Z</dcterms:modified>
</cp:coreProperties>
</file>